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bin" ContentType="application/vnd.openxmlformats-officedocument.oleObject"/>
  <Default Extension="png" ContentType="image/p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4"/>
  </p:sldMasterIdLst>
  <p:notesMasterIdLst>
    <p:notesMasterId r:id="rId10"/>
  </p:notesMasterIdLst>
  <p:sldIdLst>
    <p:sldId id="265" r:id="rId5"/>
    <p:sldId id="266" r:id="rId6"/>
    <p:sldId id="267" r:id="rId7"/>
    <p:sldId id="264" r:id="rId8"/>
    <p:sldId id="263" r:id="rId9"/>
  </p:sldIdLst>
  <p:sldSz cx="6491288" cy="86868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36">
          <p15:clr>
            <a:srgbClr val="A4A3A4"/>
          </p15:clr>
        </p15:guide>
        <p15:guide id="2" pos="204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0"/>
    <p:restoredTop sz="94554"/>
  </p:normalViewPr>
  <p:slideViewPr>
    <p:cSldViewPr snapToGrid="0" snapToObjects="1">
      <p:cViewPr>
        <p:scale>
          <a:sx n="161" d="100"/>
          <a:sy n="161" d="100"/>
        </p:scale>
        <p:origin x="1072" y="144"/>
      </p:cViewPr>
      <p:guideLst>
        <p:guide orient="horz" pos="2736"/>
        <p:guide pos="204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customXml" Target="../customXml/item1.xml"/><Relationship Id="rId2" Type="http://schemas.openxmlformats.org/officeDocument/2006/relationships/customXml" Target="../customXml/item2.xml"/><Relationship Id="rId3" Type="http://schemas.openxmlformats.org/officeDocument/2006/relationships/customXml" Target="../customXml/item3.xml"/><Relationship Id="rId4" Type="http://schemas.openxmlformats.org/officeDocument/2006/relationships/slideMaster" Target="slideMasters/slide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F95B57-0285-4C49-93DB-CF7E56F46775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6475" y="1143000"/>
            <a:ext cx="2305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1FE74F-6141-2C4A-88AD-39CCB9C158A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109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1FE74F-6141-2C4A-88AD-39CCB9C158A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3235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1FE74F-6141-2C4A-88AD-39CCB9C158A9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8251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847" y="1421660"/>
            <a:ext cx="5517595" cy="3024293"/>
          </a:xfrm>
        </p:spPr>
        <p:txBody>
          <a:bodyPr anchor="b"/>
          <a:lstStyle>
            <a:lvl1pPr algn="ctr">
              <a:defRPr sz="425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411" y="4562581"/>
            <a:ext cx="4868466" cy="2097299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566" indent="0" algn="ctr">
              <a:buNone/>
              <a:defRPr sz="1420"/>
            </a:lvl2pPr>
            <a:lvl3pPr marL="649133" indent="0" algn="ctr">
              <a:buNone/>
              <a:defRPr sz="1278"/>
            </a:lvl3pPr>
            <a:lvl4pPr marL="973699" indent="0" algn="ctr">
              <a:buNone/>
              <a:defRPr sz="1136"/>
            </a:lvl4pPr>
            <a:lvl5pPr marL="1298265" indent="0" algn="ctr">
              <a:buNone/>
              <a:defRPr sz="1136"/>
            </a:lvl5pPr>
            <a:lvl6pPr marL="1622831" indent="0" algn="ctr">
              <a:buNone/>
              <a:defRPr sz="1136"/>
            </a:lvl6pPr>
            <a:lvl7pPr marL="1947398" indent="0" algn="ctr">
              <a:buNone/>
              <a:defRPr sz="1136"/>
            </a:lvl7pPr>
            <a:lvl8pPr marL="2271964" indent="0" algn="ctr">
              <a:buNone/>
              <a:defRPr sz="1136"/>
            </a:lvl8pPr>
            <a:lvl9pPr marL="2596530" indent="0" algn="ctr">
              <a:buNone/>
              <a:defRPr sz="113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852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898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5328" y="462492"/>
            <a:ext cx="1399684" cy="736166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276" y="462492"/>
            <a:ext cx="4117911" cy="736166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65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274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895" y="2165670"/>
            <a:ext cx="5598736" cy="3613467"/>
          </a:xfrm>
        </p:spPr>
        <p:txBody>
          <a:bodyPr anchor="b"/>
          <a:lstStyle>
            <a:lvl1pPr>
              <a:defRPr sz="425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895" y="5813322"/>
            <a:ext cx="5598736" cy="1900237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/>
                </a:solidFill>
              </a:defRPr>
            </a:lvl1pPr>
            <a:lvl2pPr marL="324566" indent="0">
              <a:buNone/>
              <a:defRPr sz="1420">
                <a:solidFill>
                  <a:schemeClr val="tx1">
                    <a:tint val="75000"/>
                  </a:schemeClr>
                </a:solidFill>
              </a:defRPr>
            </a:lvl2pPr>
            <a:lvl3pPr marL="649133" indent="0">
              <a:buNone/>
              <a:defRPr sz="1278">
                <a:solidFill>
                  <a:schemeClr val="tx1">
                    <a:tint val="75000"/>
                  </a:schemeClr>
                </a:solidFill>
              </a:defRPr>
            </a:lvl3pPr>
            <a:lvl4pPr marL="973699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4pPr>
            <a:lvl5pPr marL="1298265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5pPr>
            <a:lvl6pPr marL="1622831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6pPr>
            <a:lvl7pPr marL="1947398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7pPr>
            <a:lvl8pPr marL="2271964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8pPr>
            <a:lvl9pPr marL="2596530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617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276" y="2312458"/>
            <a:ext cx="2758797" cy="551169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6215" y="2312458"/>
            <a:ext cx="2758797" cy="551169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506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121" y="462494"/>
            <a:ext cx="5598736" cy="167904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122" y="2129473"/>
            <a:ext cx="2746119" cy="104362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566" indent="0">
              <a:buNone/>
              <a:defRPr sz="1420" b="1"/>
            </a:lvl2pPr>
            <a:lvl3pPr marL="649133" indent="0">
              <a:buNone/>
              <a:defRPr sz="1278" b="1"/>
            </a:lvl3pPr>
            <a:lvl4pPr marL="973699" indent="0">
              <a:buNone/>
              <a:defRPr sz="1136" b="1"/>
            </a:lvl4pPr>
            <a:lvl5pPr marL="1298265" indent="0">
              <a:buNone/>
              <a:defRPr sz="1136" b="1"/>
            </a:lvl5pPr>
            <a:lvl6pPr marL="1622831" indent="0">
              <a:buNone/>
              <a:defRPr sz="1136" b="1"/>
            </a:lvl6pPr>
            <a:lvl7pPr marL="1947398" indent="0">
              <a:buNone/>
              <a:defRPr sz="1136" b="1"/>
            </a:lvl7pPr>
            <a:lvl8pPr marL="2271964" indent="0">
              <a:buNone/>
              <a:defRPr sz="1136" b="1"/>
            </a:lvl8pPr>
            <a:lvl9pPr marL="2596530" indent="0">
              <a:buNone/>
              <a:defRPr sz="113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122" y="3173095"/>
            <a:ext cx="2746119" cy="466714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6215" y="2129473"/>
            <a:ext cx="2759643" cy="104362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566" indent="0">
              <a:buNone/>
              <a:defRPr sz="1420" b="1"/>
            </a:lvl2pPr>
            <a:lvl3pPr marL="649133" indent="0">
              <a:buNone/>
              <a:defRPr sz="1278" b="1"/>
            </a:lvl3pPr>
            <a:lvl4pPr marL="973699" indent="0">
              <a:buNone/>
              <a:defRPr sz="1136" b="1"/>
            </a:lvl4pPr>
            <a:lvl5pPr marL="1298265" indent="0">
              <a:buNone/>
              <a:defRPr sz="1136" b="1"/>
            </a:lvl5pPr>
            <a:lvl6pPr marL="1622831" indent="0">
              <a:buNone/>
              <a:defRPr sz="1136" b="1"/>
            </a:lvl6pPr>
            <a:lvl7pPr marL="1947398" indent="0">
              <a:buNone/>
              <a:defRPr sz="1136" b="1"/>
            </a:lvl7pPr>
            <a:lvl8pPr marL="2271964" indent="0">
              <a:buNone/>
              <a:defRPr sz="1136" b="1"/>
            </a:lvl8pPr>
            <a:lvl9pPr marL="2596530" indent="0">
              <a:buNone/>
              <a:defRPr sz="113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6215" y="3173095"/>
            <a:ext cx="2759643" cy="466714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71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99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393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122" y="579120"/>
            <a:ext cx="2093609" cy="202692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9643" y="1250740"/>
            <a:ext cx="3286215" cy="6173258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122" y="2606040"/>
            <a:ext cx="2093609" cy="4828011"/>
          </a:xfrm>
        </p:spPr>
        <p:txBody>
          <a:bodyPr/>
          <a:lstStyle>
            <a:lvl1pPr marL="0" indent="0">
              <a:buNone/>
              <a:defRPr sz="1136"/>
            </a:lvl1pPr>
            <a:lvl2pPr marL="324566" indent="0">
              <a:buNone/>
              <a:defRPr sz="994"/>
            </a:lvl2pPr>
            <a:lvl3pPr marL="649133" indent="0">
              <a:buNone/>
              <a:defRPr sz="852"/>
            </a:lvl3pPr>
            <a:lvl4pPr marL="973699" indent="0">
              <a:buNone/>
              <a:defRPr sz="710"/>
            </a:lvl4pPr>
            <a:lvl5pPr marL="1298265" indent="0">
              <a:buNone/>
              <a:defRPr sz="710"/>
            </a:lvl5pPr>
            <a:lvl6pPr marL="1622831" indent="0">
              <a:buNone/>
              <a:defRPr sz="710"/>
            </a:lvl6pPr>
            <a:lvl7pPr marL="1947398" indent="0">
              <a:buNone/>
              <a:defRPr sz="710"/>
            </a:lvl7pPr>
            <a:lvl8pPr marL="2271964" indent="0">
              <a:buNone/>
              <a:defRPr sz="710"/>
            </a:lvl8pPr>
            <a:lvl9pPr marL="2596530" indent="0">
              <a:buNone/>
              <a:defRPr sz="71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620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122" y="579120"/>
            <a:ext cx="2093609" cy="202692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9643" y="1250740"/>
            <a:ext cx="3286215" cy="6173258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566" indent="0">
              <a:buNone/>
              <a:defRPr sz="1988"/>
            </a:lvl2pPr>
            <a:lvl3pPr marL="649133" indent="0">
              <a:buNone/>
              <a:defRPr sz="1704"/>
            </a:lvl3pPr>
            <a:lvl4pPr marL="973699" indent="0">
              <a:buNone/>
              <a:defRPr sz="1420"/>
            </a:lvl4pPr>
            <a:lvl5pPr marL="1298265" indent="0">
              <a:buNone/>
              <a:defRPr sz="1420"/>
            </a:lvl5pPr>
            <a:lvl6pPr marL="1622831" indent="0">
              <a:buNone/>
              <a:defRPr sz="1420"/>
            </a:lvl6pPr>
            <a:lvl7pPr marL="1947398" indent="0">
              <a:buNone/>
              <a:defRPr sz="1420"/>
            </a:lvl7pPr>
            <a:lvl8pPr marL="2271964" indent="0">
              <a:buNone/>
              <a:defRPr sz="1420"/>
            </a:lvl8pPr>
            <a:lvl9pPr marL="2596530" indent="0">
              <a:buNone/>
              <a:defRPr sz="142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122" y="2606040"/>
            <a:ext cx="2093609" cy="4828011"/>
          </a:xfrm>
        </p:spPr>
        <p:txBody>
          <a:bodyPr/>
          <a:lstStyle>
            <a:lvl1pPr marL="0" indent="0">
              <a:buNone/>
              <a:defRPr sz="1136"/>
            </a:lvl1pPr>
            <a:lvl2pPr marL="324566" indent="0">
              <a:buNone/>
              <a:defRPr sz="994"/>
            </a:lvl2pPr>
            <a:lvl3pPr marL="649133" indent="0">
              <a:buNone/>
              <a:defRPr sz="852"/>
            </a:lvl3pPr>
            <a:lvl4pPr marL="973699" indent="0">
              <a:buNone/>
              <a:defRPr sz="710"/>
            </a:lvl4pPr>
            <a:lvl5pPr marL="1298265" indent="0">
              <a:buNone/>
              <a:defRPr sz="710"/>
            </a:lvl5pPr>
            <a:lvl6pPr marL="1622831" indent="0">
              <a:buNone/>
              <a:defRPr sz="710"/>
            </a:lvl6pPr>
            <a:lvl7pPr marL="1947398" indent="0">
              <a:buNone/>
              <a:defRPr sz="710"/>
            </a:lvl7pPr>
            <a:lvl8pPr marL="2271964" indent="0">
              <a:buNone/>
              <a:defRPr sz="710"/>
            </a:lvl8pPr>
            <a:lvl9pPr marL="2596530" indent="0">
              <a:buNone/>
              <a:defRPr sz="71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809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276" y="462494"/>
            <a:ext cx="5598736" cy="16790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276" y="2312458"/>
            <a:ext cx="5598736" cy="55116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276" y="8051378"/>
            <a:ext cx="146054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DFB9CD-18F1-6B40-87D6-5EBD3A7DAD54}" type="datetimeFigureOut">
              <a:rPr lang="en-US" smtClean="0"/>
              <a:pPr/>
              <a:t>2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239" y="8051378"/>
            <a:ext cx="219081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4472" y="8051378"/>
            <a:ext cx="146054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557AE-242C-C345-A6A5-647B5130AF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100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9133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283" indent="-162283" algn="l" defTabSz="649133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849" indent="-162283" algn="l" defTabSz="649133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416" indent="-162283" algn="l" defTabSz="649133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5982" indent="-162283" algn="l" defTabSz="649133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548" indent="-162283" algn="l" defTabSz="649133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115" indent="-162283" algn="l" defTabSz="649133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09681" indent="-162283" algn="l" defTabSz="649133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247" indent="-162283" algn="l" defTabSz="649133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8813" indent="-162283" algn="l" defTabSz="649133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133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566" algn="l" defTabSz="649133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133" algn="l" defTabSz="649133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699" algn="l" defTabSz="649133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265" algn="l" defTabSz="649133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2831" algn="l" defTabSz="649133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398" algn="l" defTabSz="649133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1964" algn="l" defTabSz="649133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6530" algn="l" defTabSz="649133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4" Type="http://schemas.openxmlformats.org/officeDocument/2006/relationships/oleObject" Target="../embeddings/oleObject1.bin"/><Relationship Id="rId5" Type="http://schemas.openxmlformats.org/officeDocument/2006/relationships/image" Target="../media/image1.emf"/><Relationship Id="rId6" Type="http://schemas.openxmlformats.org/officeDocument/2006/relationships/image" Target="../media/image2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jpeg"/><Relationship Id="rId3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jpeg"/><Relationship Id="rId3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27793" y="6489921"/>
            <a:ext cx="5444066" cy="13042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Figure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1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Structure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Pam3CSK4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(Pam3)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with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the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alternation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sites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to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generate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UP3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the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ynthetic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cheme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UP3.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en-US" altLang="zh-CN" sz="1050" b="1" dirty="0" smtClean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tructur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Pam3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with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th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modification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ite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to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generat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UP3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lu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>
                <a:latin typeface="Arial" charset="0"/>
                <a:ea typeface="Arial" charset="0"/>
                <a:cs typeface="Arial" charset="0"/>
              </a:rPr>
              <a:t>arrows</a:t>
            </a:r>
            <a:r>
              <a:rPr lang="zh-CN" altLang="en-US" sz="105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>
                <a:latin typeface="Arial" charset="0"/>
                <a:ea typeface="Arial" charset="0"/>
                <a:cs typeface="Arial" charset="0"/>
              </a:rPr>
              <a:t>indicated</a:t>
            </a:r>
            <a:r>
              <a:rPr lang="zh-CN" altLang="en-US" sz="105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r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replac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by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N,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circl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“</a:t>
            </a:r>
            <a:r>
              <a:rPr lang="en-US" altLang="zh-CN" sz="1050" dirty="0" err="1" smtClean="0">
                <a:latin typeface="Arial" charset="0"/>
                <a:ea typeface="Arial" charset="0"/>
                <a:cs typeface="Arial" charset="0"/>
              </a:rPr>
              <a:t>Ser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”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in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purpl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i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replac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by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“</a:t>
            </a:r>
            <a:r>
              <a:rPr lang="en-US" altLang="zh-CN" sz="1050" dirty="0" err="1" smtClean="0">
                <a:latin typeface="Arial" charset="0"/>
                <a:ea typeface="Arial" charset="0"/>
                <a:cs typeface="Arial" charset="0"/>
              </a:rPr>
              <a:t>Gly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”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circl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“Lys”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in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r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i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removed,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thu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to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generat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UP3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ynthetic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chem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UP3.</a:t>
            </a:r>
            <a:endParaRPr lang="en-US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0944" y="304311"/>
            <a:ext cx="3419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500" dirty="0">
                <a:latin typeface="Arial" charset="0"/>
                <a:ea typeface="Arial" charset="0"/>
                <a:cs typeface="Arial" charset="0"/>
              </a:rPr>
              <a:t>A</a:t>
            </a:r>
            <a:endParaRPr lang="en-US" sz="1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50944" y="2678144"/>
            <a:ext cx="3419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500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lang="en-US" sz="1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418070" y="3001309"/>
            <a:ext cx="6491288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0493669"/>
              </p:ext>
            </p:extLst>
          </p:nvPr>
        </p:nvGraphicFramePr>
        <p:xfrm>
          <a:off x="521897" y="3007502"/>
          <a:ext cx="5644979" cy="32567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0" r:id="rId4" imgW="10477500" imgH="6045200" progId="">
                  <p:embed/>
                </p:oleObj>
              </mc:Choice>
              <mc:Fallback>
                <p:oleObj r:id="rId4" imgW="10477500" imgH="6045200" progId="">
                  <p:embed/>
                  <p:pic>
                    <p:nvPicPr>
                      <p:cNvPr id="0" name="Picture 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1897" y="3007502"/>
                        <a:ext cx="5644979" cy="3256719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672776" y="355278"/>
            <a:ext cx="5145736" cy="2287535"/>
            <a:chOff x="521897" y="355278"/>
            <a:chExt cx="5145736" cy="2287535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1897" y="1266161"/>
              <a:ext cx="5145736" cy="878021"/>
            </a:xfrm>
            <a:prstGeom prst="rect">
              <a:avLst/>
            </a:prstGeom>
          </p:spPr>
        </p:pic>
        <p:sp>
          <p:nvSpPr>
            <p:cNvPr id="15" name="Oval 14"/>
            <p:cNvSpPr/>
            <p:nvPr/>
          </p:nvSpPr>
          <p:spPr>
            <a:xfrm>
              <a:off x="2529016" y="1952365"/>
              <a:ext cx="238897" cy="238897"/>
            </a:xfrm>
            <a:prstGeom prst="ellipse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Oval 15"/>
            <p:cNvSpPr/>
            <p:nvPr/>
          </p:nvSpPr>
          <p:spPr>
            <a:xfrm>
              <a:off x="3389870" y="1952365"/>
              <a:ext cx="238897" cy="238897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167448" y="2411981"/>
              <a:ext cx="683740" cy="230832"/>
            </a:xfrm>
            <a:prstGeom prst="rect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charset="0"/>
                  <a:ea typeface="Arial" charset="0"/>
                  <a:cs typeface="Arial" charset="0"/>
                </a:rPr>
                <a:t>Removed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595382" y="355278"/>
              <a:ext cx="11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smtClean="0">
                  <a:latin typeface="Arial" charset="0"/>
                  <a:ea typeface="Arial" charset="0"/>
                  <a:cs typeface="Arial" charset="0"/>
                </a:rPr>
                <a:t>Pam3CSK4</a:t>
              </a:r>
              <a:endParaRPr lang="en-US" sz="12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 flipH="1" flipV="1">
              <a:off x="3509049" y="2196269"/>
              <a:ext cx="269" cy="21047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>
              <a:off x="3579339" y="1042544"/>
              <a:ext cx="0" cy="259030"/>
            </a:xfrm>
            <a:prstGeom prst="straightConnector1">
              <a:avLst/>
            </a:prstGeom>
            <a:ln w="12700">
              <a:solidFill>
                <a:srgbClr val="00B0F0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>
              <a:off x="3747946" y="1924194"/>
              <a:ext cx="427366" cy="486925"/>
            </a:xfrm>
            <a:prstGeom prst="straightConnector1">
              <a:avLst/>
            </a:prstGeom>
            <a:ln w="12700">
              <a:solidFill>
                <a:srgbClr val="00B0F0"/>
              </a:solidFill>
              <a:headEnd type="stealth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3978164" y="2411981"/>
              <a:ext cx="974152" cy="230832"/>
            </a:xfrm>
            <a:prstGeom prst="rect">
              <a:avLst/>
            </a:prstGeom>
            <a:ln>
              <a:solidFill>
                <a:srgbClr val="00B0F0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charset="0"/>
                  <a:ea typeface="Arial" charset="0"/>
                  <a:cs typeface="Arial" charset="0"/>
                </a:rPr>
                <a:t>Replaced</a:t>
              </a:r>
              <a:r>
                <a:rPr lang="zh-CN" altLang="en-US" sz="900" dirty="0" smtClean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zh-CN" sz="900" dirty="0" smtClean="0">
                  <a:latin typeface="Arial" charset="0"/>
                  <a:ea typeface="Arial" charset="0"/>
                  <a:cs typeface="Arial" charset="0"/>
                </a:rPr>
                <a:t>by</a:t>
              </a:r>
              <a:r>
                <a:rPr lang="zh-CN" altLang="en-US" sz="900" dirty="0" smtClean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zh-CN" sz="900" dirty="0" smtClean="0">
                  <a:latin typeface="Arial" charset="0"/>
                  <a:ea typeface="Arial" charset="0"/>
                  <a:cs typeface="Arial" charset="0"/>
                </a:rPr>
                <a:t>N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092263" y="807643"/>
              <a:ext cx="974152" cy="230832"/>
            </a:xfrm>
            <a:prstGeom prst="rect">
              <a:avLst/>
            </a:prstGeom>
            <a:ln>
              <a:solidFill>
                <a:srgbClr val="00B0F0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charset="0"/>
                  <a:ea typeface="Arial" charset="0"/>
                  <a:cs typeface="Arial" charset="0"/>
                </a:rPr>
                <a:t>Replaced</a:t>
              </a:r>
              <a:r>
                <a:rPr lang="zh-CN" altLang="en-US" sz="900" dirty="0" smtClean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zh-CN" sz="900" dirty="0" smtClean="0">
                  <a:latin typeface="Arial" charset="0"/>
                  <a:ea typeface="Arial" charset="0"/>
                  <a:cs typeface="Arial" charset="0"/>
                </a:rPr>
                <a:t>by</a:t>
              </a:r>
              <a:r>
                <a:rPr lang="zh-CN" altLang="en-US" sz="900" dirty="0" smtClean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zh-CN" sz="900" dirty="0" smtClean="0">
                  <a:latin typeface="Arial" charset="0"/>
                  <a:ea typeface="Arial" charset="0"/>
                  <a:cs typeface="Arial" charset="0"/>
                </a:rPr>
                <a:t>N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20" name="Straight Connector 21"/>
            <p:cNvCxnSpPr/>
            <p:nvPr/>
          </p:nvCxnSpPr>
          <p:spPr>
            <a:xfrm flipV="1">
              <a:off x="2648464" y="2189758"/>
              <a:ext cx="0" cy="216981"/>
            </a:xfrm>
            <a:prstGeom prst="line">
              <a:avLst/>
            </a:prstGeom>
            <a:ln w="127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16"/>
            <p:cNvSpPr txBox="1"/>
            <p:nvPr/>
          </p:nvSpPr>
          <p:spPr>
            <a:xfrm>
              <a:off x="1936112" y="2411981"/>
              <a:ext cx="1116227" cy="230832"/>
            </a:xfrm>
            <a:prstGeom prst="rect">
              <a:avLst/>
            </a:prstGeom>
            <a:ln>
              <a:solidFill>
                <a:srgbClr val="7030A0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Replaced by </a:t>
              </a:r>
              <a:r>
                <a:rPr lang="en-US" altLang="zh-CN" sz="900" dirty="0" err="1" smtClean="0">
                  <a:latin typeface="Arial" charset="0"/>
                  <a:ea typeface="Arial" charset="0"/>
                  <a:cs typeface="Arial" charset="0"/>
                </a:rPr>
                <a:t>Gly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82611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428367" y="420129"/>
            <a:ext cx="6491288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99"/>
          <a:stretch/>
        </p:blipFill>
        <p:spPr>
          <a:xfrm>
            <a:off x="131805" y="420133"/>
            <a:ext cx="6270833" cy="425896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6461" y="97441"/>
            <a:ext cx="3419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500" dirty="0">
                <a:latin typeface="Arial" charset="0"/>
                <a:ea typeface="Arial" charset="0"/>
                <a:cs typeface="Arial" charset="0"/>
              </a:rPr>
              <a:t>A</a:t>
            </a:r>
            <a:endParaRPr lang="en-US" sz="1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6461" y="4624601"/>
            <a:ext cx="3419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500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lang="en-US" sz="1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02855" y="6817758"/>
            <a:ext cx="5444066" cy="1546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F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igure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2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Chemical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characterization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UP3.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en-US" altLang="zh-CN" sz="1050" b="1" dirty="0" smtClean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aseline="30000" dirty="0" smtClean="0"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H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nuclear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magnetic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resonanc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NMR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UP3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Electrospray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ionization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mas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pectrum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ESI-MS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UP3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pt-BR" sz="1050" baseline="30000" dirty="0">
                <a:latin typeface="Arial" charset="0"/>
                <a:ea typeface="Arial" charset="0"/>
                <a:cs typeface="Arial" charset="0"/>
              </a:rPr>
              <a:t>1</a:t>
            </a:r>
            <a:r>
              <a:rPr lang="pt-BR" sz="1050" dirty="0">
                <a:latin typeface="Arial" charset="0"/>
                <a:ea typeface="Arial" charset="0"/>
                <a:cs typeface="Arial" charset="0"/>
              </a:rPr>
              <a:t>H NMR (DMSO </a:t>
            </a:r>
            <a:r>
              <a:rPr lang="pt-BR" sz="1050" i="1" dirty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pt-BR" sz="1050" dirty="0">
                <a:latin typeface="Arial" charset="0"/>
                <a:ea typeface="Arial" charset="0"/>
                <a:cs typeface="Arial" charset="0"/>
              </a:rPr>
              <a:t>-6): </a:t>
            </a:r>
            <a:r>
              <a:rPr lang="en-US" sz="1050" dirty="0" err="1">
                <a:latin typeface="Times New Roman" charset="0"/>
                <a:ea typeface="Times New Roman" charset="0"/>
                <a:cs typeface="Times New Roman" charset="0"/>
              </a:rPr>
              <a:t>δ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 5.03-5.00 (m, 1H), 4.48-4.45 (m, 1H), 4.42-4.32 (m, 3H), 4.19-4.16 (t, 1H), 3.96-3.92 (d, 1H), 3.87-3.83 (d, 1H), 3.10-3.07 (t, 5H), 2.98-2.94 (m, 6H), 2.90-2.76 (m, 3H), 2.34-2.29 (m, 2H), 1.95-1.88 (m, 3H), 1.81-1.62 (m, 11H), 1.54-1.48 (m, 10H), 1.30 (m, 68H), 0.93 (t, 9H).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ESI-</a:t>
            </a:r>
            <a:r>
              <a:rPr lang="pt-BR" sz="1050" dirty="0" smtClean="0">
                <a:latin typeface="Arial" charset="0"/>
                <a:ea typeface="Arial" charset="0"/>
                <a:cs typeface="Arial" charset="0"/>
              </a:rPr>
              <a:t>MS </a:t>
            </a:r>
            <a:r>
              <a:rPr lang="pt-BR" sz="1050" dirty="0">
                <a:latin typeface="Arial" charset="0"/>
                <a:ea typeface="Arial" charset="0"/>
                <a:cs typeface="Arial" charset="0"/>
              </a:rPr>
              <a:t>[M+H] = 1354.0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.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49101" y="457506"/>
            <a:ext cx="64008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smtClean="0">
                <a:latin typeface="Arial" charset="0"/>
                <a:ea typeface="Arial" charset="0"/>
                <a:cs typeface="Arial" charset="0"/>
              </a:rPr>
              <a:t>SUP3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775422" y="4674931"/>
            <a:ext cx="64008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smtClean="0">
                <a:latin typeface="Arial" charset="0"/>
                <a:ea typeface="Arial" charset="0"/>
                <a:cs typeface="Arial" charset="0"/>
              </a:rPr>
              <a:t>SUP3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189" y="5025024"/>
            <a:ext cx="5846064" cy="17861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4239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2734" y="2918986"/>
            <a:ext cx="5444066" cy="2516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Figure S3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ffinities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plasma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tabilities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UP3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Pam3.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en-US" altLang="zh-CN" sz="1050" b="1" dirty="0" smtClean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TLR2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ffinitie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UP3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Pam3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HEK-Blu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hTLR2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zh-CN" sz="1050" dirty="0" err="1" smtClean="0">
                <a:latin typeface="Arial" charset="0"/>
                <a:ea typeface="Arial" charset="0"/>
                <a:cs typeface="Arial" charset="0"/>
              </a:rPr>
              <a:t>Invivogen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cat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>
                <a:latin typeface="Arial" charset="0"/>
                <a:ea typeface="Arial" charset="0"/>
                <a:cs typeface="Arial" charset="0"/>
              </a:rPr>
              <a:t>h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kb-htlr2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reporter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cell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cultur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in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HEK-Blu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Detection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medium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zh-CN" sz="1050" dirty="0" err="1">
                <a:latin typeface="Arial" charset="0"/>
                <a:ea typeface="Arial" charset="0"/>
                <a:cs typeface="Arial" charset="0"/>
              </a:rPr>
              <a:t>Invivogen</a:t>
            </a:r>
            <a:r>
              <a:rPr lang="en-US" altLang="zh-CN" sz="1050" dirty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zh-CN" altLang="en-US" sz="105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>
                <a:latin typeface="Arial" charset="0"/>
                <a:ea typeface="Arial" charset="0"/>
                <a:cs typeface="Arial" charset="0"/>
              </a:rPr>
              <a:t>cat.</a:t>
            </a:r>
            <a:r>
              <a:rPr lang="zh-CN" altLang="en-US" sz="105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hb-det2) wer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timulat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by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variou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dose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UP3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Pam3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Optical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density at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655nm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OD655) wa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determin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24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h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post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timulation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Plasma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tabilitie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of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UP3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Pam3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i="1" dirty="0" smtClean="0">
                <a:latin typeface="Arial" charset="0"/>
                <a:ea typeface="Arial" charset="0"/>
                <a:cs typeface="Arial" charset="0"/>
              </a:rPr>
              <a:t>in</a:t>
            </a:r>
            <a:r>
              <a:rPr lang="zh-CN" altLang="en-US" sz="1050" i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i="1" dirty="0" smtClean="0">
                <a:latin typeface="Arial" charset="0"/>
                <a:ea typeface="Arial" charset="0"/>
                <a:cs typeface="Arial" charset="0"/>
              </a:rPr>
              <a:t>vitro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The test compounds were added to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mouse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plasma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pre-incubated 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for 5 min at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37 </a:t>
            </a:r>
            <a:r>
              <a:rPr lang="zh-CN" altLang="en-US" sz="1050" dirty="0" smtClean="0"/>
              <a:t>℃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(final concentrations of compounds were 1 </a:t>
            </a:r>
            <a:r>
              <a:rPr lang="en-US" sz="1050" dirty="0" err="1" smtClean="0">
                <a:latin typeface="Times New Roman" charset="0"/>
                <a:ea typeface="Times New Roman" charset="0"/>
                <a:cs typeface="Times New Roman" charset="0"/>
              </a:rPr>
              <a:t>μ</a:t>
            </a:r>
            <a:r>
              <a:rPr lang="en-US" sz="1050" dirty="0" err="1" smtClean="0">
                <a:latin typeface="Arial" charset="0"/>
                <a:ea typeface="Arial" charset="0"/>
                <a:cs typeface="Arial" charset="0"/>
              </a:rPr>
              <a:t>M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). After incubation for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1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h,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3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h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or 5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h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at 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37 </a:t>
            </a:r>
            <a:r>
              <a:rPr lang="zh-CN" altLang="en-US" sz="1050" dirty="0" smtClean="0"/>
              <a:t>℃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reactions were stopped by adding 3 times volume of methanol. Then the sample were centrifuged and remaining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compounds 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in supernatants were analyzed by liquid chromatography-mass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spectrometry (LC-MS). </a:t>
            </a:r>
            <a:endParaRPr lang="en-US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51781" y="302419"/>
            <a:ext cx="3419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500" dirty="0">
                <a:latin typeface="Arial" charset="0"/>
                <a:ea typeface="Arial" charset="0"/>
                <a:cs typeface="Arial" charset="0"/>
              </a:rPr>
              <a:t>A</a:t>
            </a:r>
            <a:endParaRPr lang="en-US" sz="1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49826" y="302419"/>
            <a:ext cx="3419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500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lang="en-US" sz="15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0779" y="846995"/>
            <a:ext cx="2555115" cy="18505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734" y="625584"/>
            <a:ext cx="2281892" cy="21135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9251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513" y="305459"/>
            <a:ext cx="3165033" cy="418121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51645" y="4461936"/>
            <a:ext cx="5444066" cy="1546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Figure S4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UP3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Pam3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induced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antigen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US" altLang="zh-CN" sz="105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cells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at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various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doses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upon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immunization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by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OCS.</a:t>
            </a:r>
            <a:endParaRPr lang="en-US" altLang="zh-CN" sz="1050" b="1" dirty="0" smtClean="0">
              <a:solidFill>
                <a:srgbClr val="00B050"/>
              </a:solidFill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WT mice were immunized by OC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2×10</a:t>
            </a:r>
            <a:r>
              <a:rPr lang="en-US" sz="1050" baseline="30000" dirty="0">
                <a:latin typeface="Arial" charset="0"/>
                <a:ea typeface="Arial" charset="0"/>
                <a:cs typeface="Arial" charset="0"/>
              </a:rPr>
              <a:t>7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 cells per mouse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 with SUP3 or Pam3 at indicated doses (0.2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err="1" smtClean="0">
                <a:latin typeface="Arial" charset="0"/>
                <a:ea typeface="Arial" charset="0"/>
                <a:cs typeface="Arial" charset="0"/>
              </a:rPr>
              <a:t>nmol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err="1" smtClean="0">
                <a:latin typeface="Arial" charset="0"/>
                <a:ea typeface="Arial" charset="0"/>
                <a:cs typeface="Arial" charset="0"/>
              </a:rPr>
              <a:t>nmol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10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err="1" smtClean="0">
                <a:latin typeface="Arial" charset="0"/>
                <a:ea typeface="Arial" charset="0"/>
                <a:cs typeface="Arial" charset="0"/>
              </a:rPr>
              <a:t>nmol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)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for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7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day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nd analyzed as described in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Figure 2A.</a:t>
            </a:r>
            <a:r>
              <a:rPr lang="zh-CN" altLang="en-US" sz="1050" b="1" dirty="0" smtClean="0">
                <a:solidFill>
                  <a:srgbClr val="00B050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OVA-specific 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US" sz="105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 T 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cells 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were determined by flow cytometry </a:t>
            </a:r>
            <a:r>
              <a:rPr lang="en-US" sz="1050" b="1" dirty="0">
                <a:latin typeface="Arial" charset="0"/>
                <a:ea typeface="Arial" charset="0"/>
                <a:cs typeface="Arial" charset="0"/>
              </a:rPr>
              <a:t>(A)</a:t>
            </a:r>
            <a:r>
              <a:rPr lang="en-US" sz="1050" dirty="0">
                <a:latin typeface="Arial" charset="0"/>
                <a:ea typeface="Arial" charset="0"/>
                <a:cs typeface="Arial" charset="0"/>
              </a:rPr>
              <a:t> and the statistic calculation is presented in (</a:t>
            </a:r>
            <a:r>
              <a:rPr lang="en-US" sz="105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050" dirty="0" smtClean="0">
                <a:latin typeface="Arial" charset="0"/>
                <a:ea typeface="Arial" charset="0"/>
                <a:cs typeface="Arial" charset="0"/>
              </a:rPr>
              <a:t>).</a:t>
            </a:r>
            <a:endParaRPr lang="en-US" sz="1050" b="1" dirty="0">
              <a:solidFill>
                <a:srgbClr val="00B05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1560" y="280518"/>
            <a:ext cx="3419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500" dirty="0">
                <a:latin typeface="Arial" charset="0"/>
                <a:ea typeface="Arial" charset="0"/>
                <a:cs typeface="Arial" charset="0"/>
              </a:rPr>
              <a:t>A</a:t>
            </a:r>
            <a:endParaRPr lang="en-US" sz="15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8654" y="603684"/>
            <a:ext cx="1947057" cy="179238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562971" y="280518"/>
            <a:ext cx="3419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500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lang="en-US" sz="15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0427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059" y="475967"/>
            <a:ext cx="4094571" cy="38505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51645" y="4461936"/>
            <a:ext cx="5444066" cy="8194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Figure S5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TLR2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expression</a:t>
            </a:r>
            <a:r>
              <a:rPr lang="zh-CN" altLang="en-US" sz="105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by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immune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b="1" dirty="0">
                <a:latin typeface="Arial" charset="0"/>
                <a:ea typeface="Arial" charset="0"/>
                <a:cs typeface="Arial" charset="0"/>
              </a:rPr>
              <a:t>cells</a:t>
            </a:r>
            <a:r>
              <a:rPr lang="en-US" altLang="zh-CN" sz="105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zh-CN" altLang="en-US" sz="1050" b="1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en-US" altLang="zh-CN" sz="1050" b="1" dirty="0" smtClean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Variou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immun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cell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wer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tain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by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nti-TLR2-P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analyzed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by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flow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cytometry.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Gray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shadows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represent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isotype</a:t>
            </a:r>
            <a:r>
              <a:rPr lang="zh-CN" altLang="en-US" sz="105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1050" dirty="0" smtClean="0">
                <a:latin typeface="Arial" charset="0"/>
                <a:ea typeface="Arial" charset="0"/>
                <a:cs typeface="Arial" charset="0"/>
              </a:rPr>
              <a:t>control.</a:t>
            </a:r>
            <a:endParaRPr lang="en-US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1560" y="280518"/>
            <a:ext cx="34190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500" dirty="0">
                <a:latin typeface="Arial" charset="0"/>
                <a:ea typeface="Arial" charset="0"/>
                <a:cs typeface="Arial" charset="0"/>
              </a:rPr>
              <a:t>A</a:t>
            </a:r>
            <a:endParaRPr lang="en-US" sz="15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12252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>
  <documentManagement>
    <IsDeleted xmlns="68118f12-96e1-4e45-8ea3-accd1fe4d757">false</IsDeleted>
    <DocumentType xmlns="68118f12-96e1-4e45-8ea3-accd1fe4d757">Presentation</DocumentType>
    <StageName xmlns="68118f12-96e1-4e45-8ea3-accd1fe4d757">Author's Proof</StageName>
    <DocumentId xmlns="68118f12-96e1-4e45-8ea3-accd1fe4d757">Presentation 1.pptx</DocumentId>
    <TitleName xmlns="68118f12-96e1-4e45-8ea3-accd1fe4d757">Presentation 1.pptx</TitleName>
    <FileFormat xmlns="68118f12-96e1-4e45-8ea3-accd1fe4d757">PPTX</FileFormat>
    <Checked_x0020_Out_x0020_To xmlns="68118f12-96e1-4e45-8ea3-accd1fe4d757">
      <UserInfo>
        <DisplayName/>
        <AccountId xsi:nil="true"/>
        <AccountType/>
      </UserInfo>
    </Checked_x0020_Out_x0020_To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1FF8541CEF3F14980589EA4F5FF9280" ma:contentTypeVersion="7" ma:contentTypeDescription="Create a new document." ma:contentTypeScope="" ma:versionID="2b833b15ff64fd7f74466e23ba538b1a">
  <xsd:schema xmlns:xsd="http://www.w3.org/2001/XMLSchema" xmlns:p="http://schemas.microsoft.com/office/2006/metadata/properties" xmlns:ns2="68118f12-96e1-4e45-8ea3-accd1fe4d757" targetNamespace="http://schemas.microsoft.com/office/2006/metadata/properties" ma:root="true" ma:fieldsID="e3ce7c63bac4685fb546f2bd90134be7" ns2:_="">
    <xsd:import namespace="68118f12-96e1-4e45-8ea3-accd1fe4d757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68118f12-96e1-4e45-8ea3-accd1fe4d757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E43E490F-4270-46C0-93E4-F21AE2B5FD5A}"/>
</file>

<file path=customXml/itemProps2.xml><?xml version="1.0" encoding="utf-8"?>
<ds:datastoreItem xmlns:ds="http://schemas.openxmlformats.org/officeDocument/2006/customXml" ds:itemID="{4904C700-9E29-47BE-9875-DF169C18E0BD}"/>
</file>

<file path=customXml/itemProps3.xml><?xml version="1.0" encoding="utf-8"?>
<ds:datastoreItem xmlns:ds="http://schemas.openxmlformats.org/officeDocument/2006/customXml" ds:itemID="{41C675CD-A81B-45EC-89C3-4DF5B03A28C8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2</TotalTime>
  <Words>506</Words>
  <Application>Microsoft Macintosh PowerPoint</Application>
  <PresentationFormat>Custom</PresentationFormat>
  <Paragraphs>28</Paragraphs>
  <Slides>5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Calibri</vt:lpstr>
      <vt:lpstr>Calibri Light</vt:lpstr>
      <vt:lpstr>Times New Roman</vt:lpstr>
      <vt:lpstr>宋体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ueheng Guo</dc:creator>
  <cp:lastModifiedBy>Xueheng Guo</cp:lastModifiedBy>
  <cp:revision>115</cp:revision>
  <cp:lastPrinted>2016-12-21T06:22:46Z</cp:lastPrinted>
  <dcterms:created xsi:type="dcterms:W3CDTF">2016-12-25T15:48:45Z</dcterms:created>
  <dcterms:modified xsi:type="dcterms:W3CDTF">2017-02-06T10:01:32Z</dcterms:modified>
</cp:coreProperties>
</file>